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3FD15-5018-4B49-A133-5FE62F3E36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F619F-188B-471B-B6D0-F824EFF8C5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EB3AC-ADAA-4121-BE13-3B1ACB2A2C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4ABB6-1D39-44E8-A51C-C2B502F26F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1B2F7-1173-42FA-B9CD-45D7911EBE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F1092-6D8A-4291-BC17-E00567A3B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64174-45FD-40BA-8831-6C89297F26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33B70-75CE-46B2-B9AA-47D82C22E7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DC4B0-2940-4B99-885C-4E737C39E0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F36CA-05DF-4218-BD12-1702190E16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DC001-CFF4-4D68-B2FD-7C0F11A946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8B3DB-32AA-43FB-A16C-38E2A2F7F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505FF2-C321-45B1-8009-27A65B822B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62080" y="324000"/>
            <a:ext cx="5238720" cy="7632360"/>
            <a:chOff x="262080" y="324000"/>
            <a:chExt cx="5238720" cy="7632360"/>
          </a:xfrm>
        </p:grpSpPr>
        <p:sp>
          <p:nvSpPr>
            <p:cNvPr id="42" name=""/>
            <p:cNvSpPr/>
            <p:nvPr/>
          </p:nvSpPr>
          <p:spPr>
            <a:xfrm>
              <a:off x="2216160" y="5945040"/>
              <a:ext cx="0" cy="168120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173320" y="7626240"/>
              <a:ext cx="42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173320" y="734868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173320" y="707076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173320" y="679284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173320" y="650088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173320" y="622296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173320" y="5945040"/>
              <a:ext cx="4284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216160" y="7626240"/>
              <a:ext cx="2558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2216160" y="7626240"/>
              <a:ext cx="0" cy="4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2581200" y="7626240"/>
              <a:ext cx="0" cy="4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2948040" y="7626240"/>
              <a:ext cx="0" cy="44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3313080" y="7626240"/>
              <a:ext cx="0" cy="446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3678120" y="7626240"/>
              <a:ext cx="0" cy="446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4043520" y="7626240"/>
              <a:ext cx="0" cy="446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4410000" y="7626240"/>
              <a:ext cx="0" cy="446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4775040" y="7626240"/>
              <a:ext cx="0" cy="446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216160" y="7304040"/>
              <a:ext cx="2455920" cy="322200"/>
            </a:xfrm>
            <a:custGeom>
              <a:avLst/>
              <a:gdLst/>
              <a:ahLst/>
              <a:rect l="l" t="t" r="r" b="b"/>
              <a:pathLst>
                <a:path w="168" h="22">
                  <a:moveTo>
                    <a:pt x="0" y="22"/>
                  </a:moveTo>
                  <a:lnTo>
                    <a:pt x="4" y="22"/>
                  </a:lnTo>
                  <a:lnTo>
                    <a:pt x="8" y="0"/>
                  </a:lnTo>
                  <a:lnTo>
                    <a:pt x="24" y="22"/>
                  </a:lnTo>
                  <a:lnTo>
                    <a:pt x="48" y="22"/>
                  </a:lnTo>
                  <a:lnTo>
                    <a:pt x="120" y="22"/>
                  </a:lnTo>
                  <a:lnTo>
                    <a:pt x="168" y="22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216160" y="6267600"/>
              <a:ext cx="2455920" cy="1358640"/>
            </a:xfrm>
            <a:custGeom>
              <a:avLst/>
              <a:gdLst/>
              <a:ahLst/>
              <a:rect l="l" t="t" r="r" b="b"/>
              <a:pathLst>
                <a:path w="168" h="93">
                  <a:moveTo>
                    <a:pt x="0" y="93"/>
                  </a:moveTo>
                  <a:lnTo>
                    <a:pt x="4" y="0"/>
                  </a:lnTo>
                  <a:lnTo>
                    <a:pt x="8" y="93"/>
                  </a:lnTo>
                  <a:lnTo>
                    <a:pt x="24" y="93"/>
                  </a:lnTo>
                  <a:lnTo>
                    <a:pt x="48" y="86"/>
                  </a:lnTo>
                  <a:lnTo>
                    <a:pt x="120" y="47"/>
                  </a:lnTo>
                  <a:lnTo>
                    <a:pt x="168" y="93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14308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0176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260440" y="72309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49408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84472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89736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599000" y="7553160"/>
              <a:ext cx="131760" cy="1317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143080" y="7553160"/>
              <a:ext cx="146160" cy="14616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201760" y="6194520"/>
              <a:ext cx="146160" cy="14580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260440" y="7553160"/>
              <a:ext cx="146160" cy="14616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494080" y="7553160"/>
              <a:ext cx="145800" cy="14616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44720" y="7451640"/>
              <a:ext cx="146160" cy="14616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897360" y="6880320"/>
              <a:ext cx="146160" cy="145800"/>
            </a:xfrm>
            <a:custGeom>
              <a:avLst/>
              <a:gdLst/>
              <a:ahLst/>
              <a:rect l="l" t="t" r="r" b="b"/>
              <a:pathLst>
                <a:path w="92" h="92">
                  <a:moveTo>
                    <a:pt x="46" y="0"/>
                  </a:moveTo>
                  <a:lnTo>
                    <a:pt x="92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599000" y="7553160"/>
              <a:ext cx="147600" cy="146160"/>
            </a:xfrm>
            <a:custGeom>
              <a:avLst/>
              <a:gdLst/>
              <a:ahLst/>
              <a:rect l="l" t="t" r="r" b="b"/>
              <a:pathLst>
                <a:path w="93" h="92">
                  <a:moveTo>
                    <a:pt x="46" y="0"/>
                  </a:moveTo>
                  <a:lnTo>
                    <a:pt x="93" y="46"/>
                  </a:lnTo>
                  <a:lnTo>
                    <a:pt x="46" y="92"/>
                  </a:lnTo>
                  <a:lnTo>
                    <a:pt x="0" y="46"/>
                  </a:lnTo>
                  <a:lnTo>
                    <a:pt x="4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011320" y="752472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837080" y="72468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837080" y="696924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837080" y="669132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837080" y="639756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837080" y="612144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837080" y="584352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73320" y="775800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494080" y="77580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859120" y="77580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225960" y="77580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547080" y="77580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13560" y="77580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2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278600" y="77580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644000" y="77580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7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042880" y="7596360"/>
              <a:ext cx="4579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hours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201600" y="6618960"/>
              <a:ext cx="20491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Serum IL-6 levels after the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369000" y="6627240"/>
              <a:ext cx="21495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second AAV administration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6200000">
              <a:off x="1354680" y="6590160"/>
              <a:ext cx="5493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(pg/ml)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4" name=""/>
            <p:cNvGrpSpPr/>
            <p:nvPr/>
          </p:nvGrpSpPr>
          <p:grpSpPr>
            <a:xfrm>
              <a:off x="2781360" y="4284720"/>
              <a:ext cx="1603080" cy="555480"/>
              <a:chOff x="2781360" y="4284720"/>
              <a:chExt cx="1603080" cy="555480"/>
            </a:xfrm>
          </p:grpSpPr>
          <p:sp>
            <p:nvSpPr>
              <p:cNvPr id="95" name=""/>
              <p:cNvSpPr/>
              <p:nvPr/>
            </p:nvSpPr>
            <p:spPr>
              <a:xfrm>
                <a:off x="2781360" y="4284720"/>
                <a:ext cx="1603080" cy="55548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847600" y="4430520"/>
                <a:ext cx="461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020040" y="4387680"/>
                <a:ext cx="85320" cy="72720"/>
              </a:xfrm>
              <a:prstGeom prst="rect">
                <a:avLst/>
              </a:prstGeom>
              <a:solidFill>
                <a:srgbClr val="ffffff"/>
              </a:solidFill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362400" y="4329000"/>
                <a:ext cx="8967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000000"/>
                    </a:solidFill>
                    <a:latin typeface="Arial"/>
                  </a:rPr>
                  <a:t>NHP  w/o IS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847600" y="4708440"/>
                <a:ext cx="4615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020040" y="4663800"/>
                <a:ext cx="101880" cy="88560"/>
              </a:xfrm>
              <a:custGeom>
                <a:avLst/>
                <a:gdLst/>
                <a:ahLst/>
                <a:rect l="l" t="t" r="r" b="b"/>
                <a:pathLst>
                  <a:path w="55" h="56">
                    <a:moveTo>
                      <a:pt x="27" y="0"/>
                    </a:moveTo>
                    <a:lnTo>
                      <a:pt x="55" y="28"/>
                    </a:lnTo>
                    <a:lnTo>
                      <a:pt x="27" y="56"/>
                    </a:lnTo>
                    <a:lnTo>
                      <a:pt x="0" y="28"/>
                    </a:lnTo>
                    <a:lnTo>
                      <a:pt x="27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361320" y="4606920"/>
                <a:ext cx="8877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000000"/>
                    </a:solidFill>
                    <a:latin typeface="Arial"/>
                  </a:rPr>
                  <a:t>NHP with IS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2" name=""/>
            <p:cNvSpPr/>
            <p:nvPr/>
          </p:nvSpPr>
          <p:spPr>
            <a:xfrm>
              <a:off x="335160" y="434988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62080" y="32400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058840" y="3475080"/>
              <a:ext cx="51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058840" y="319392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058840" y="290196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058840" y="262080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058840" y="232740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058840" y="204804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058840" y="175428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058840" y="1473120"/>
              <a:ext cx="5112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058840" y="3425760"/>
              <a:ext cx="87480" cy="85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048040" y="3413160"/>
              <a:ext cx="122040" cy="122040"/>
            </a:xfrm>
            <a:custGeom>
              <a:avLst/>
              <a:gdLst/>
              <a:ahLst/>
              <a:rect l="l" t="t" r="r" b="b"/>
              <a:pathLst>
                <a:path w="60" h="60">
                  <a:moveTo>
                    <a:pt x="30" y="0"/>
                  </a:moveTo>
                  <a:lnTo>
                    <a:pt x="60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109960" y="1473120"/>
              <a:ext cx="0" cy="200196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109960" y="3475080"/>
              <a:ext cx="2562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V="1">
              <a:off x="2109960" y="3475080"/>
              <a:ext cx="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109960" y="1779480"/>
              <a:ext cx="2463480" cy="1695600"/>
            </a:xfrm>
            <a:custGeom>
              <a:avLst/>
              <a:gdLst/>
              <a:ahLst/>
              <a:rect l="l" t="t" r="r" b="b"/>
              <a:pathLst>
                <a:path w="249" h="139">
                  <a:moveTo>
                    <a:pt x="0" y="139"/>
                  </a:moveTo>
                  <a:lnTo>
                    <a:pt x="6" y="139"/>
                  </a:lnTo>
                  <a:lnTo>
                    <a:pt x="12" y="0"/>
                  </a:lnTo>
                  <a:lnTo>
                    <a:pt x="36" y="139"/>
                  </a:lnTo>
                  <a:lnTo>
                    <a:pt x="71" y="139"/>
                  </a:lnTo>
                  <a:lnTo>
                    <a:pt x="178" y="139"/>
                  </a:lnTo>
                  <a:lnTo>
                    <a:pt x="249" y="139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109960" y="3475080"/>
              <a:ext cx="2463480" cy="360"/>
            </a:xfrm>
            <a:custGeom>
              <a:avLst/>
              <a:gdLst/>
              <a:ahLst/>
              <a:rect l="l" t="t" r="r" b="b"/>
              <a:pathLst>
                <a:path w="249" h="0">
                  <a:moveTo>
                    <a:pt x="0" y="0"/>
                  </a:moveTo>
                  <a:lnTo>
                    <a:pt x="6" y="0"/>
                  </a:lnTo>
                  <a:lnTo>
                    <a:pt x="12" y="0"/>
                  </a:lnTo>
                  <a:lnTo>
                    <a:pt x="36" y="0"/>
                  </a:lnTo>
                  <a:lnTo>
                    <a:pt x="71" y="0"/>
                  </a:lnTo>
                  <a:lnTo>
                    <a:pt x="178" y="0"/>
                  </a:lnTo>
                  <a:lnTo>
                    <a:pt x="249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119320" y="3413160"/>
              <a:ext cx="98280" cy="122040"/>
            </a:xfrm>
            <a:custGeom>
              <a:avLst/>
              <a:gdLst/>
              <a:ahLst/>
              <a:rect l="l" t="t" r="r" b="b"/>
              <a:pathLst>
                <a:path w="60" h="60">
                  <a:moveTo>
                    <a:pt x="30" y="0"/>
                  </a:moveTo>
                  <a:lnTo>
                    <a:pt x="60" y="30"/>
                  </a:lnTo>
                  <a:lnTo>
                    <a:pt x="30" y="60"/>
                  </a:lnTo>
                  <a:lnTo>
                    <a:pt x="0" y="3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128680" y="3425760"/>
              <a:ext cx="69840" cy="85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" name=""/>
            <p:cNvGrpSpPr/>
            <p:nvPr/>
          </p:nvGrpSpPr>
          <p:grpSpPr>
            <a:xfrm>
              <a:off x="2173320" y="1727280"/>
              <a:ext cx="2498760" cy="1807920"/>
              <a:chOff x="2173320" y="1727280"/>
              <a:chExt cx="2498760" cy="1807920"/>
            </a:xfrm>
          </p:grpSpPr>
          <p:sp>
            <p:nvSpPr>
              <p:cNvPr id="122" name=""/>
              <p:cNvSpPr/>
              <p:nvPr/>
            </p:nvSpPr>
            <p:spPr>
              <a:xfrm flipV="1">
                <a:off x="247464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 flipV="1">
                <a:off x="284076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320688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 flipV="1">
                <a:off x="357336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 flipV="1">
                <a:off x="393948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 flipV="1">
                <a:off x="430560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4672080" y="3475080"/>
                <a:ext cx="0" cy="4752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173320" y="1727280"/>
                <a:ext cx="120600" cy="108000"/>
              </a:xfrm>
              <a:prstGeom prst="rect">
                <a:avLst/>
              </a:prstGeom>
              <a:solidFill>
                <a:srgbClr val="ffffff"/>
              </a:solidFill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426400" y="3425760"/>
                <a:ext cx="68400" cy="85680"/>
              </a:xfrm>
              <a:prstGeom prst="rect">
                <a:avLst/>
              </a:prstGeom>
              <a:solidFill>
                <a:srgbClr val="ffffff"/>
              </a:solidFill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772000" y="3425760"/>
                <a:ext cx="68400" cy="85680"/>
              </a:xfrm>
              <a:prstGeom prst="rect">
                <a:avLst/>
              </a:prstGeom>
              <a:solidFill>
                <a:srgbClr val="ffffff"/>
              </a:solidFill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830040" y="3425760"/>
                <a:ext cx="69480" cy="85680"/>
              </a:xfrm>
              <a:prstGeom prst="rect">
                <a:avLst/>
              </a:prstGeom>
              <a:solidFill>
                <a:srgbClr val="ffffff"/>
              </a:solidFill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533120" y="3425760"/>
                <a:ext cx="68760" cy="85680"/>
              </a:xfrm>
              <a:prstGeom prst="rect">
                <a:avLst/>
              </a:prstGeom>
              <a:solidFill>
                <a:srgbClr val="ffffff"/>
              </a:solidFill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178360" y="3413160"/>
                <a:ext cx="99000" cy="122040"/>
              </a:xfrm>
              <a:custGeom>
                <a:avLst/>
                <a:gdLst/>
                <a:ahLst/>
                <a:rect l="l" t="t" r="r" b="b"/>
                <a:pathLst>
                  <a:path w="60" h="60">
                    <a:moveTo>
                      <a:pt x="30" y="0"/>
                    </a:moveTo>
                    <a:lnTo>
                      <a:pt x="60" y="30"/>
                    </a:lnTo>
                    <a:lnTo>
                      <a:pt x="30" y="60"/>
                    </a:lnTo>
                    <a:lnTo>
                      <a:pt x="0" y="3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415960" y="3413160"/>
                <a:ext cx="99000" cy="122040"/>
              </a:xfrm>
              <a:custGeom>
                <a:avLst/>
                <a:gdLst/>
                <a:ahLst/>
                <a:rect l="l" t="t" r="r" b="b"/>
                <a:pathLst>
                  <a:path w="60" h="60">
                    <a:moveTo>
                      <a:pt x="30" y="0"/>
                    </a:moveTo>
                    <a:lnTo>
                      <a:pt x="60" y="30"/>
                    </a:lnTo>
                    <a:lnTo>
                      <a:pt x="30" y="60"/>
                    </a:lnTo>
                    <a:lnTo>
                      <a:pt x="0" y="3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761920" y="3413160"/>
                <a:ext cx="99000" cy="122040"/>
              </a:xfrm>
              <a:custGeom>
                <a:avLst/>
                <a:gdLst/>
                <a:ahLst/>
                <a:rect l="l" t="t" r="r" b="b"/>
                <a:pathLst>
                  <a:path w="60" h="60">
                    <a:moveTo>
                      <a:pt x="30" y="0"/>
                    </a:moveTo>
                    <a:lnTo>
                      <a:pt x="60" y="30"/>
                    </a:lnTo>
                    <a:lnTo>
                      <a:pt x="30" y="60"/>
                    </a:lnTo>
                    <a:lnTo>
                      <a:pt x="0" y="3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819960" y="3413160"/>
                <a:ext cx="99000" cy="122040"/>
              </a:xfrm>
              <a:custGeom>
                <a:avLst/>
                <a:gdLst/>
                <a:ahLst/>
                <a:rect l="l" t="t" r="r" b="b"/>
                <a:pathLst>
                  <a:path w="60" h="60">
                    <a:moveTo>
                      <a:pt x="30" y="0"/>
                    </a:moveTo>
                    <a:lnTo>
                      <a:pt x="60" y="30"/>
                    </a:lnTo>
                    <a:lnTo>
                      <a:pt x="30" y="60"/>
                    </a:lnTo>
                    <a:lnTo>
                      <a:pt x="0" y="3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523040" y="3413160"/>
                <a:ext cx="99000" cy="122040"/>
              </a:xfrm>
              <a:custGeom>
                <a:avLst/>
                <a:gdLst/>
                <a:ahLst/>
                <a:rect l="l" t="t" r="r" b="b"/>
                <a:pathLst>
                  <a:path w="60" h="60">
                    <a:moveTo>
                      <a:pt x="30" y="0"/>
                    </a:moveTo>
                    <a:lnTo>
                      <a:pt x="60" y="30"/>
                    </a:lnTo>
                    <a:lnTo>
                      <a:pt x="30" y="60"/>
                    </a:lnTo>
                    <a:lnTo>
                      <a:pt x="0" y="3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9" name=""/>
            <p:cNvSpPr/>
            <p:nvPr/>
          </p:nvSpPr>
          <p:spPr>
            <a:xfrm>
              <a:off x="1898640" y="337644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812960" y="309564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812960" y="280368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812960" y="252252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812960" y="223056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726200" y="19494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726200" y="165744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726200" y="137628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rot="16200000">
              <a:off x="92880" y="2322360"/>
              <a:ext cx="21585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Serum IL-6 levels after first 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rot="16200000">
              <a:off x="698760" y="2516760"/>
              <a:ext cx="1573560" cy="39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AAV administration 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(pg/ml)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084400" y="363060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405160" y="36306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770200" y="36306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137040" y="3630600"/>
              <a:ext cx="1836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458160" y="36306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824640" y="36306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2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190040" y="36306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555080" y="3630600"/>
              <a:ext cx="2750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7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953960" y="3468600"/>
              <a:ext cx="4579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hours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9T10:16:03Z</dcterms:created>
  <dc:creator>Centro de Tecnología Informática</dc:creator>
  <dc:description/>
  <dc:language>en-US</dc:language>
  <cp:lastModifiedBy>Centro de Tecnología Informática</cp:lastModifiedBy>
  <dcterms:modified xsi:type="dcterms:W3CDTF">2011-10-14T10:41:21Z</dcterms:modified>
  <cp:revision>6</cp:revision>
  <dc:subject/>
  <dc:title>Diapositiva 1</dc:title>
</cp:coreProperties>
</file>